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6" r:id="rId4"/>
    <p:sldId id="257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939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316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008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477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167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407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41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651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075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963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110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944B8-B0C6-465A-8D7F-FE21069A08BA}" type="datetimeFigureOut">
              <a:rPr lang="en-US" smtClean="0"/>
              <a:t>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BDFC3-197B-4E40-9E58-5AF712C59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13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793602" y="885172"/>
            <a:ext cx="3136899" cy="2632601"/>
          </a:xfrm>
        </p:spPr>
        <p:txBody>
          <a:bodyPr>
            <a:normAutofit/>
          </a:bodyPr>
          <a:lstStyle/>
          <a:p>
            <a:pPr algn="l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Raw Western blot images for TOV21G and SHT290 Figure 2A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ι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OV21G and SHT290 cells at 50% and serum free (SF)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ζ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OV21G and SHT290 cells at 50% and serum free (SF)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in TOV21G and SHT290 cells at 50% and serum free (SF). Rows 3 and 4 were used for the TOV21G image and rows 7 and 8 were used for the SHT290 imag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2890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58636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62890" y="3517774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822014" y="-23342"/>
            <a:ext cx="2981992" cy="410023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4985123" y="-23342"/>
            <a:ext cx="2981992" cy="410023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822015" y="3270796"/>
            <a:ext cx="2981992" cy="4100239"/>
          </a:xfrm>
          <a:prstGeom prst="rect">
            <a:avLst/>
          </a:prstGeom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8646903"/>
              </p:ext>
            </p:extLst>
          </p:nvPr>
        </p:nvGraphicFramePr>
        <p:xfrm>
          <a:off x="945518" y="676339"/>
          <a:ext cx="223120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8900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19033114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52181745"/>
                    </a:ext>
                  </a:extLst>
                </a:gridCol>
              </a:tblGrid>
              <a:tr h="370840">
                <a:tc gridSpan="8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7275285"/>
              </p:ext>
            </p:extLst>
          </p:nvPr>
        </p:nvGraphicFramePr>
        <p:xfrm>
          <a:off x="5760314" y="623746"/>
          <a:ext cx="223120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8900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19033114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52181745"/>
                    </a:ext>
                  </a:extLst>
                </a:gridCol>
              </a:tblGrid>
              <a:tr h="370840">
                <a:tc gridSpan="8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3568853"/>
              </p:ext>
            </p:extLst>
          </p:nvPr>
        </p:nvGraphicFramePr>
        <p:xfrm>
          <a:off x="1301118" y="3927061"/>
          <a:ext cx="223120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8900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19033114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52181745"/>
                    </a:ext>
                  </a:extLst>
                </a:gridCol>
              </a:tblGrid>
              <a:tr h="370840">
                <a:tc gridSpan="8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059982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50301" y="4687211"/>
            <a:ext cx="3136899" cy="1655762"/>
          </a:xfrm>
        </p:spPr>
        <p:txBody>
          <a:bodyPr>
            <a:normAutofit/>
          </a:bodyPr>
          <a:lstStyle/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Raw Western blot images for ES-2 Figure 2A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ι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ES-2 cells at 50% and serum free (SF). Bands are loaded in the opposite order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ζ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ES-2 cells at 50% and serum free (SF). Bands are loaded in the opposite order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in ES-2 cells at 50% and serum free (SF). Bands are loaded in the opposite order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2890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58636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7230" y="223636"/>
            <a:ext cx="2981992" cy="410023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0301" y="223636"/>
            <a:ext cx="2981992" cy="410023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2342" y="223636"/>
            <a:ext cx="2981992" cy="4100239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7747699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83610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02701" y="182814"/>
            <a:ext cx="3136899" cy="1655762"/>
          </a:xfrm>
        </p:spPr>
        <p:txBody>
          <a:bodyPr>
            <a:normAutofit/>
          </a:bodyPr>
          <a:lstStyle/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Raw Western blot images for TOV21G Figure 2B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ι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corresponding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in TOV21G cells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ζ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corresponding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in TOV21G cel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800424" y="-376309"/>
            <a:ext cx="2981992" cy="410023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192051" y="-376308"/>
            <a:ext cx="2981992" cy="410023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800424" y="2812853"/>
            <a:ext cx="2981992" cy="410023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192052" y="2812852"/>
            <a:ext cx="2981992" cy="410023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62890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41300" y="3390090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00563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009137" y="-313232"/>
            <a:ext cx="2981992" cy="410023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764186" y="-328826"/>
            <a:ext cx="2981992" cy="410023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753391" y="2853221"/>
            <a:ext cx="2981992" cy="4100239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009137" y="2853220"/>
            <a:ext cx="2981992" cy="4100239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02701" y="182814"/>
            <a:ext cx="3136899" cy="1655762"/>
          </a:xfrm>
        </p:spPr>
        <p:txBody>
          <a:bodyPr>
            <a:normAutofit/>
          </a:bodyPr>
          <a:lstStyle/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 Raw Western blot images for ES-2 Figure 2B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ι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corresponding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in ES-2 cells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ζ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corresponding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in ES-2 cel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2890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41300" y="3390090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4183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1083" y="348621"/>
            <a:ext cx="4090718" cy="1655762"/>
          </a:xfrm>
        </p:spPr>
        <p:txBody>
          <a:bodyPr>
            <a:normAutofit/>
          </a:bodyPr>
          <a:lstStyle/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 Raw Western blot images for TOV21G Rac1 PD utilizing GST PAK-PBD Figure 7D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Rac1 exposure time of 1 minute. Rows 1 and 2 are the positive and negative control, respectively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Rac1 exposure time of 2 minutes. The positive control is saturated (marked in pink). Rows 5 and 6 are the vehicle control and 10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treatment for TOV21G cell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2890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46168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3048" y="348621"/>
            <a:ext cx="2981992" cy="410023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214" y="330351"/>
            <a:ext cx="2981992" cy="4100239"/>
          </a:xfrm>
          <a:prstGeom prst="rect">
            <a:avLst/>
          </a:prstGeom>
        </p:spPr>
      </p:pic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2742215"/>
              </p:ext>
            </p:extLst>
          </p:nvPr>
        </p:nvGraphicFramePr>
        <p:xfrm>
          <a:off x="5027962" y="1412939"/>
          <a:ext cx="167340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8900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</a:tblGrid>
              <a:tr h="370840">
                <a:tc gridSpan="6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5972878"/>
              </p:ext>
            </p:extLst>
          </p:nvPr>
        </p:nvGraphicFramePr>
        <p:xfrm>
          <a:off x="1402128" y="1418509"/>
          <a:ext cx="167340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8900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</a:tblGrid>
              <a:tr h="370840">
                <a:tc gridSpan="6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835365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90" y="540449"/>
            <a:ext cx="4100239" cy="298199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864543" y="3243049"/>
            <a:ext cx="2981992" cy="410023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042842" y="-18674"/>
            <a:ext cx="2981992" cy="4100239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767665" y="348620"/>
            <a:ext cx="3094136" cy="2572379"/>
          </a:xfrm>
        </p:spPr>
        <p:txBody>
          <a:bodyPr>
            <a:normAutofit/>
          </a:bodyPr>
          <a:lstStyle/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 Raw Western blot images for TOV21G RhoA and PKC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ζ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decrease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RhoA in TOV21G cells with vehicle control (Row 2) and 3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treatment (Row 3)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PKC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ζ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OV21G cells with vehicle control (Row 2) and 3μM treatment (Row 3).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OV21G cells with vehicle control (Row 2) and 3μM treatment (Row 3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2890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46168" y="223636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1307465"/>
              </p:ext>
            </p:extLst>
          </p:nvPr>
        </p:nvGraphicFramePr>
        <p:xfrm>
          <a:off x="5697138" y="893129"/>
          <a:ext cx="167340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8900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</a:tblGrid>
              <a:tr h="370840">
                <a:tc gridSpan="6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882972"/>
              </p:ext>
            </p:extLst>
          </p:nvPr>
        </p:nvGraphicFramePr>
        <p:xfrm>
          <a:off x="1319947" y="752232"/>
          <a:ext cx="1829652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4942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304942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304942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304942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304942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304942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</a:tblGrid>
              <a:tr h="370840">
                <a:tc gridSpan="6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262890" y="3479674"/>
            <a:ext cx="267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7929461"/>
              </p:ext>
            </p:extLst>
          </p:nvPr>
        </p:nvGraphicFramePr>
        <p:xfrm>
          <a:off x="1358047" y="3813478"/>
          <a:ext cx="1673400" cy="741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8900">
                  <a:extLst>
                    <a:ext uri="{9D8B030D-6E8A-4147-A177-3AD203B41FA5}">
                      <a16:colId xmlns:a16="http://schemas.microsoft.com/office/drawing/2014/main" val="1251279398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360633790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9292521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4171041904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634713595"/>
                    </a:ext>
                  </a:extLst>
                </a:gridCol>
                <a:gridCol w="278900">
                  <a:extLst>
                    <a:ext uri="{9D8B030D-6E8A-4147-A177-3AD203B41FA5}">
                      <a16:colId xmlns:a16="http://schemas.microsoft.com/office/drawing/2014/main" val="2532010084"/>
                    </a:ext>
                  </a:extLst>
                </a:gridCol>
              </a:tblGrid>
              <a:tr h="370840">
                <a:tc gridSpan="6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w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6454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22902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1672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547</Words>
  <Application>Microsoft Office PowerPoint</Application>
  <PresentationFormat>Widescreen</PresentationFormat>
  <Paragraphs>8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South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alley, Tracess</dc:creator>
  <cp:lastModifiedBy>Smalley, Tracess</cp:lastModifiedBy>
  <cp:revision>13</cp:revision>
  <dcterms:created xsi:type="dcterms:W3CDTF">2019-07-23T17:58:36Z</dcterms:created>
  <dcterms:modified xsi:type="dcterms:W3CDTF">2019-07-27T18:27:27Z</dcterms:modified>
</cp:coreProperties>
</file>